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5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结实率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结实率!$E$3:$E$32</c:f>
              <c:numCache>
                <c:formatCode>0.00_ </c:formatCode>
                <c:ptCount val="30"/>
                <c:pt idx="0">
                  <c:v>75.434396786932936</c:v>
                </c:pt>
                <c:pt idx="1">
                  <c:v>71.494492139612262</c:v>
                </c:pt>
                <c:pt idx="2">
                  <c:v>71.799103566621554</c:v>
                </c:pt>
                <c:pt idx="3">
                  <c:v>69.527302798148739</c:v>
                </c:pt>
                <c:pt idx="4">
                  <c:v>71.379546143697652</c:v>
                </c:pt>
                <c:pt idx="5">
                  <c:v>71.820492441337592</c:v>
                </c:pt>
                <c:pt idx="6">
                  <c:v>72.693878774104235</c:v>
                </c:pt>
                <c:pt idx="7">
                  <c:v>68.753037935440361</c:v>
                </c:pt>
                <c:pt idx="8">
                  <c:v>69.439657227617332</c:v>
                </c:pt>
                <c:pt idx="9">
                  <c:v>71.625679963689279</c:v>
                </c:pt>
                <c:pt idx="10">
                  <c:v>71.930395252828362</c:v>
                </c:pt>
                <c:pt idx="11">
                  <c:v>70.178781782231198</c:v>
                </c:pt>
                <c:pt idx="12">
                  <c:v>71.690483939857714</c:v>
                </c:pt>
                <c:pt idx="13">
                  <c:v>72.491877036308267</c:v>
                </c:pt>
                <c:pt idx="14">
                  <c:v>71.107165194165631</c:v>
                </c:pt>
                <c:pt idx="15">
                  <c:v>70.399796411250108</c:v>
                </c:pt>
                <c:pt idx="16">
                  <c:v>69.933687587234417</c:v>
                </c:pt>
                <c:pt idx="17">
                  <c:v>72.36538683589815</c:v>
                </c:pt>
                <c:pt idx="18">
                  <c:v>79.386972603370609</c:v>
                </c:pt>
                <c:pt idx="19">
                  <c:v>73.850359964942029</c:v>
                </c:pt>
                <c:pt idx="20">
                  <c:v>71.386660447358565</c:v>
                </c:pt>
                <c:pt idx="21">
                  <c:v>71.321807609362068</c:v>
                </c:pt>
                <c:pt idx="22">
                  <c:v>72.372462058343771</c:v>
                </c:pt>
                <c:pt idx="23">
                  <c:v>69.378524273707271</c:v>
                </c:pt>
                <c:pt idx="24">
                  <c:v>75.729283066981594</c:v>
                </c:pt>
                <c:pt idx="25">
                  <c:v>74.851100957283634</c:v>
                </c:pt>
                <c:pt idx="26">
                  <c:v>73.724864745346693</c:v>
                </c:pt>
                <c:pt idx="27">
                  <c:v>72.673780484187958</c:v>
                </c:pt>
                <c:pt idx="28">
                  <c:v>75.039029174964028</c:v>
                </c:pt>
                <c:pt idx="29">
                  <c:v>73.530120471602586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结实率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结实率!$N$3:$N$32</c:f>
              <c:numCache>
                <c:formatCode>General</c:formatCode>
                <c:ptCount val="30"/>
                <c:pt idx="0">
                  <c:v>79.094514259869371</c:v>
                </c:pt>
                <c:pt idx="1">
                  <c:v>74.849523515418824</c:v>
                </c:pt>
                <c:pt idx="2">
                  <c:v>72.908972242531547</c:v>
                </c:pt>
                <c:pt idx="3">
                  <c:v>70.942535263186699</c:v>
                </c:pt>
                <c:pt idx="4">
                  <c:v>72.271545785153307</c:v>
                </c:pt>
                <c:pt idx="5">
                  <c:v>72.748212790458737</c:v>
                </c:pt>
                <c:pt idx="6">
                  <c:v>74.866584532087032</c:v>
                </c:pt>
                <c:pt idx="7">
                  <c:v>69.858734337153649</c:v>
                </c:pt>
                <c:pt idx="8">
                  <c:v>71.322029859338642</c:v>
                </c:pt>
                <c:pt idx="9">
                  <c:v>76.081574636527577</c:v>
                </c:pt>
                <c:pt idx="10">
                  <c:v>71.506618622542746</c:v>
                </c:pt>
                <c:pt idx="11">
                  <c:v>68.577002952333586</c:v>
                </c:pt>
                <c:pt idx="12">
                  <c:v>73.859393429440658</c:v>
                </c:pt>
                <c:pt idx="13">
                  <c:v>72.838709173154754</c:v>
                </c:pt>
                <c:pt idx="14">
                  <c:v>72.274941341145862</c:v>
                </c:pt>
                <c:pt idx="15">
                  <c:v>69.088419538678906</c:v>
                </c:pt>
                <c:pt idx="16">
                  <c:v>73.605056282062307</c:v>
                </c:pt>
                <c:pt idx="17">
                  <c:v>74.258889677074109</c:v>
                </c:pt>
                <c:pt idx="18">
                  <c:v>84.611253171050748</c:v>
                </c:pt>
                <c:pt idx="19">
                  <c:v>72.193771048651797</c:v>
                </c:pt>
                <c:pt idx="20">
                  <c:v>72.09957299235694</c:v>
                </c:pt>
                <c:pt idx="21">
                  <c:v>71.839076588778155</c:v>
                </c:pt>
                <c:pt idx="22">
                  <c:v>70.788346970523349</c:v>
                </c:pt>
                <c:pt idx="23">
                  <c:v>71.197269440636589</c:v>
                </c:pt>
                <c:pt idx="24">
                  <c:v>75.021104649429688</c:v>
                </c:pt>
                <c:pt idx="25">
                  <c:v>77.108287374312198</c:v>
                </c:pt>
                <c:pt idx="26">
                  <c:v>74.448144764082429</c:v>
                </c:pt>
                <c:pt idx="27">
                  <c:v>71.799436119026069</c:v>
                </c:pt>
                <c:pt idx="28">
                  <c:v>76.920421455128107</c:v>
                </c:pt>
                <c:pt idx="29">
                  <c:v>75.904460145187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223680"/>
        <c:axId val="216213760"/>
      </c:barChart>
      <c:catAx>
        <c:axId val="215223680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16213760"/>
        <c:crosses val="autoZero"/>
        <c:auto val="1"/>
        <c:lblAlgn val="ctr"/>
        <c:lblOffset val="100"/>
        <c:noMultiLvlLbl val="0"/>
      </c:catAx>
      <c:valAx>
        <c:axId val="216213760"/>
        <c:scaling>
          <c:orientation val="minMax"/>
        </c:scaling>
        <c:delete val="0"/>
        <c:axPos val="b"/>
        <c:numFmt formatCode="0.00_ 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152236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7971842"/>
              </p:ext>
            </p:extLst>
          </p:nvPr>
        </p:nvGraphicFramePr>
        <p:xfrm>
          <a:off x="381000" y="367358"/>
          <a:ext cx="5372100" cy="82807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981200" y="8651776"/>
            <a:ext cx="1752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Seed set </a:t>
            </a:r>
            <a:r>
              <a:rPr lang="en-US" altLang="zh-CN" sz="1600" b="1" dirty="0"/>
              <a:t>rate </a:t>
            </a:r>
            <a:r>
              <a:rPr lang="en-US" altLang="zh-CN" sz="1600" b="1" dirty="0" smtClean="0"/>
              <a:t>(%)</a:t>
            </a:r>
            <a:endParaRPr lang="en-US" sz="16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5257800" y="50418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35</a:t>
            </a:r>
            <a:endParaRPr lang="en-US" sz="800" spc="-10" dirty="0"/>
          </a:p>
        </p:txBody>
      </p:sp>
      <p:sp>
        <p:nvSpPr>
          <p:cNvPr id="97" name="TextBox 96"/>
          <p:cNvSpPr txBox="1"/>
          <p:nvPr/>
        </p:nvSpPr>
        <p:spPr>
          <a:xfrm>
            <a:off x="5257800" y="76558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0</a:t>
            </a:r>
            <a:endParaRPr lang="en-US" sz="800" spc="-10" dirty="0"/>
          </a:p>
        </p:txBody>
      </p:sp>
      <p:sp>
        <p:nvSpPr>
          <p:cNvPr id="98" name="TextBox 97"/>
          <p:cNvSpPr txBox="1"/>
          <p:nvPr/>
        </p:nvSpPr>
        <p:spPr>
          <a:xfrm>
            <a:off x="5257800" y="102698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99" name="TextBox 98"/>
          <p:cNvSpPr txBox="1"/>
          <p:nvPr/>
        </p:nvSpPr>
        <p:spPr>
          <a:xfrm>
            <a:off x="5257800" y="12883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83</a:t>
            </a:r>
            <a:endParaRPr lang="en-US" sz="800" spc="-10" dirty="0"/>
          </a:p>
        </p:txBody>
      </p:sp>
      <p:sp>
        <p:nvSpPr>
          <p:cNvPr id="100" name="TextBox 99"/>
          <p:cNvSpPr txBox="1"/>
          <p:nvPr/>
        </p:nvSpPr>
        <p:spPr>
          <a:xfrm>
            <a:off x="5257800" y="15497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34</a:t>
            </a:r>
            <a:endParaRPr lang="en-US" sz="800" spc="-10" dirty="0"/>
          </a:p>
        </p:txBody>
      </p:sp>
      <p:sp>
        <p:nvSpPr>
          <p:cNvPr id="101" name="TextBox 100"/>
          <p:cNvSpPr txBox="1"/>
          <p:nvPr/>
        </p:nvSpPr>
        <p:spPr>
          <a:xfrm>
            <a:off x="5257800" y="1811190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7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81</a:t>
            </a:r>
            <a:endParaRPr lang="en-US" sz="800" spc="-10" dirty="0"/>
          </a:p>
        </p:txBody>
      </p:sp>
      <p:sp>
        <p:nvSpPr>
          <p:cNvPr id="102" name="TextBox 101"/>
          <p:cNvSpPr txBox="1"/>
          <p:nvPr/>
        </p:nvSpPr>
        <p:spPr>
          <a:xfrm>
            <a:off x="5257800" y="207259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81</a:t>
            </a:r>
            <a:endParaRPr lang="en-US" sz="800" spc="-10" dirty="0"/>
          </a:p>
        </p:txBody>
      </p:sp>
      <p:sp>
        <p:nvSpPr>
          <p:cNvPr id="103" name="TextBox 102"/>
          <p:cNvSpPr txBox="1"/>
          <p:nvPr/>
        </p:nvSpPr>
        <p:spPr>
          <a:xfrm>
            <a:off x="5257800" y="23339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1</a:t>
            </a:r>
            <a:endParaRPr lang="en-US" sz="800" spc="-10" dirty="0"/>
          </a:p>
        </p:txBody>
      </p:sp>
      <p:sp>
        <p:nvSpPr>
          <p:cNvPr id="104" name="TextBox 103"/>
          <p:cNvSpPr txBox="1"/>
          <p:nvPr/>
        </p:nvSpPr>
        <p:spPr>
          <a:xfrm>
            <a:off x="5257800" y="25953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3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28</a:t>
            </a:r>
            <a:endParaRPr lang="en-US" sz="800" spc="-10" dirty="0"/>
          </a:p>
        </p:txBody>
      </p:sp>
      <p:sp>
        <p:nvSpPr>
          <p:cNvPr id="105" name="TextBox 104"/>
          <p:cNvSpPr txBox="1"/>
          <p:nvPr/>
        </p:nvSpPr>
        <p:spPr>
          <a:xfrm>
            <a:off x="5257800" y="285679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4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9</a:t>
            </a:r>
            <a:endParaRPr lang="en-US" sz="800" spc="-10" dirty="0"/>
          </a:p>
        </p:txBody>
      </p:sp>
      <p:sp>
        <p:nvSpPr>
          <p:cNvPr id="106" name="TextBox 105"/>
          <p:cNvSpPr txBox="1"/>
          <p:nvPr/>
        </p:nvSpPr>
        <p:spPr>
          <a:xfrm>
            <a:off x="5257800" y="311819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01</a:t>
            </a:r>
            <a:endParaRPr lang="en-US" sz="800" spc="-10" dirty="0"/>
          </a:p>
        </p:txBody>
      </p:sp>
      <p:sp>
        <p:nvSpPr>
          <p:cNvPr id="107" name="TextBox 106"/>
          <p:cNvSpPr txBox="1"/>
          <p:nvPr/>
        </p:nvSpPr>
        <p:spPr>
          <a:xfrm>
            <a:off x="5257800" y="337959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7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108" name="TextBox 107"/>
          <p:cNvSpPr txBox="1"/>
          <p:nvPr/>
        </p:nvSpPr>
        <p:spPr>
          <a:xfrm>
            <a:off x="5257800" y="36409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65</a:t>
            </a:r>
            <a:endParaRPr lang="en-US" sz="800" spc="-10" dirty="0"/>
          </a:p>
        </p:txBody>
      </p:sp>
      <p:sp>
        <p:nvSpPr>
          <p:cNvPr id="109" name="TextBox 108"/>
          <p:cNvSpPr txBox="1"/>
          <p:nvPr/>
        </p:nvSpPr>
        <p:spPr>
          <a:xfrm>
            <a:off x="5257800" y="3902398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1</a:t>
            </a:r>
            <a:endParaRPr lang="en-US" sz="800" spc="-10" dirty="0"/>
          </a:p>
        </p:txBody>
      </p:sp>
      <p:sp>
        <p:nvSpPr>
          <p:cNvPr id="110" name="TextBox 109"/>
          <p:cNvSpPr txBox="1"/>
          <p:nvPr/>
        </p:nvSpPr>
        <p:spPr>
          <a:xfrm>
            <a:off x="5257800" y="416379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3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4</a:t>
            </a:r>
            <a:endParaRPr lang="en-US" sz="800" spc="-10" dirty="0"/>
          </a:p>
        </p:txBody>
      </p:sp>
      <p:sp>
        <p:nvSpPr>
          <p:cNvPr id="111" name="TextBox 110"/>
          <p:cNvSpPr txBox="1"/>
          <p:nvPr/>
        </p:nvSpPr>
        <p:spPr>
          <a:xfrm>
            <a:off x="5257800" y="44252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6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1</a:t>
            </a:r>
            <a:endParaRPr lang="en-US" sz="800" spc="-10" dirty="0"/>
          </a:p>
        </p:txBody>
      </p:sp>
      <p:sp>
        <p:nvSpPr>
          <p:cNvPr id="112" name="TextBox 111"/>
          <p:cNvSpPr txBox="1"/>
          <p:nvPr/>
        </p:nvSpPr>
        <p:spPr>
          <a:xfrm>
            <a:off x="5257800" y="46866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8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2</a:t>
            </a:r>
            <a:endParaRPr lang="en-US" sz="800" spc="-10" dirty="0"/>
          </a:p>
        </p:txBody>
      </p:sp>
      <p:sp>
        <p:nvSpPr>
          <p:cNvPr id="113" name="TextBox 112"/>
          <p:cNvSpPr txBox="1"/>
          <p:nvPr/>
        </p:nvSpPr>
        <p:spPr>
          <a:xfrm>
            <a:off x="5257800" y="4948002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07</a:t>
            </a:r>
            <a:endParaRPr lang="en-US" sz="800" spc="-10" dirty="0"/>
          </a:p>
        </p:txBody>
      </p:sp>
      <p:sp>
        <p:nvSpPr>
          <p:cNvPr id="114" name="TextBox 113"/>
          <p:cNvSpPr txBox="1"/>
          <p:nvPr/>
        </p:nvSpPr>
        <p:spPr>
          <a:xfrm>
            <a:off x="5257800" y="520940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38</a:t>
            </a:r>
            <a:endParaRPr lang="en-US" sz="800" spc="-10" dirty="0"/>
          </a:p>
        </p:txBody>
      </p:sp>
      <p:sp>
        <p:nvSpPr>
          <p:cNvPr id="115" name="TextBox 114"/>
          <p:cNvSpPr txBox="1"/>
          <p:nvPr/>
        </p:nvSpPr>
        <p:spPr>
          <a:xfrm>
            <a:off x="5257800" y="547080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25</a:t>
            </a:r>
            <a:endParaRPr lang="en-US" sz="800" spc="-10" dirty="0"/>
          </a:p>
        </p:txBody>
      </p:sp>
      <p:sp>
        <p:nvSpPr>
          <p:cNvPr id="116" name="TextBox 115"/>
          <p:cNvSpPr txBox="1"/>
          <p:nvPr/>
        </p:nvSpPr>
        <p:spPr>
          <a:xfrm>
            <a:off x="5257800" y="573220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1</a:t>
            </a:r>
            <a:endParaRPr lang="en-US" sz="800" spc="-10" dirty="0"/>
          </a:p>
        </p:txBody>
      </p:sp>
      <p:sp>
        <p:nvSpPr>
          <p:cNvPr id="117" name="TextBox 116"/>
          <p:cNvSpPr txBox="1"/>
          <p:nvPr/>
        </p:nvSpPr>
        <p:spPr>
          <a:xfrm>
            <a:off x="5257800" y="599360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6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21</a:t>
            </a:r>
            <a:endParaRPr lang="en-US" sz="800" spc="-10" dirty="0"/>
          </a:p>
        </p:txBody>
      </p:sp>
      <p:sp>
        <p:nvSpPr>
          <p:cNvPr id="118" name="TextBox 117"/>
          <p:cNvSpPr txBox="1"/>
          <p:nvPr/>
        </p:nvSpPr>
        <p:spPr>
          <a:xfrm>
            <a:off x="5257800" y="625500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95</a:t>
            </a:r>
            <a:endParaRPr lang="en-US" sz="800" spc="-10" dirty="0"/>
          </a:p>
        </p:txBody>
      </p:sp>
      <p:sp>
        <p:nvSpPr>
          <p:cNvPr id="119" name="TextBox 118"/>
          <p:cNvSpPr txBox="1"/>
          <p:nvPr/>
        </p:nvSpPr>
        <p:spPr>
          <a:xfrm>
            <a:off x="5257800" y="651640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70</a:t>
            </a:r>
            <a:endParaRPr lang="en-US" sz="800" spc="-10" dirty="0"/>
          </a:p>
        </p:txBody>
      </p:sp>
      <p:sp>
        <p:nvSpPr>
          <p:cNvPr id="120" name="TextBox 119"/>
          <p:cNvSpPr txBox="1"/>
          <p:nvPr/>
        </p:nvSpPr>
        <p:spPr>
          <a:xfrm>
            <a:off x="5257800" y="6777808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0</a:t>
            </a:r>
            <a:endParaRPr lang="en-US" sz="800" spc="-10" dirty="0"/>
          </a:p>
        </p:txBody>
      </p:sp>
      <p:sp>
        <p:nvSpPr>
          <p:cNvPr id="121" name="TextBox 120"/>
          <p:cNvSpPr txBox="1"/>
          <p:nvPr/>
        </p:nvSpPr>
        <p:spPr>
          <a:xfrm>
            <a:off x="5257800" y="7039210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06</a:t>
            </a:r>
            <a:endParaRPr lang="en-US" sz="800" spc="-10" dirty="0"/>
          </a:p>
        </p:txBody>
      </p:sp>
      <p:sp>
        <p:nvSpPr>
          <p:cNvPr id="122" name="TextBox 121"/>
          <p:cNvSpPr txBox="1"/>
          <p:nvPr/>
        </p:nvSpPr>
        <p:spPr>
          <a:xfrm>
            <a:off x="5257800" y="730061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1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2</a:t>
            </a:r>
            <a:endParaRPr lang="en-US" sz="800" spc="-10" dirty="0"/>
          </a:p>
        </p:txBody>
      </p:sp>
      <p:sp>
        <p:nvSpPr>
          <p:cNvPr id="123" name="TextBox 122"/>
          <p:cNvSpPr txBox="1"/>
          <p:nvPr/>
        </p:nvSpPr>
        <p:spPr>
          <a:xfrm>
            <a:off x="5257800" y="75620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7</a:t>
            </a:r>
            <a:endParaRPr lang="en-US" sz="800" spc="-10" dirty="0"/>
          </a:p>
        </p:txBody>
      </p:sp>
      <p:sp>
        <p:nvSpPr>
          <p:cNvPr id="124" name="TextBox 123"/>
          <p:cNvSpPr txBox="1"/>
          <p:nvPr/>
        </p:nvSpPr>
        <p:spPr>
          <a:xfrm>
            <a:off x="5257800" y="78234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6.9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9</a:t>
            </a:r>
            <a:endParaRPr lang="en-US" sz="800" spc="-10" dirty="0"/>
          </a:p>
        </p:txBody>
      </p:sp>
      <p:sp>
        <p:nvSpPr>
          <p:cNvPr id="125" name="TextBox 124"/>
          <p:cNvSpPr txBox="1"/>
          <p:nvPr/>
        </p:nvSpPr>
        <p:spPr>
          <a:xfrm>
            <a:off x="5257800" y="808482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3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2</a:t>
            </a:r>
            <a:endParaRPr lang="en-US" sz="2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099374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908275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8:16Z</dcterms:modified>
</cp:coreProperties>
</file>